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56" r:id="rId9"/>
    <p:sldId id="265" r:id="rId10"/>
    <p:sldId id="26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7"/>
    <p:restoredTop sz="94648"/>
  </p:normalViewPr>
  <p:slideViewPr>
    <p:cSldViewPr snapToGrid="0">
      <p:cViewPr>
        <p:scale>
          <a:sx n="80" d="100"/>
          <a:sy n="80" d="100"/>
        </p:scale>
        <p:origin x="288" y="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28C844-FC98-6433-1491-E5284FFB5E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AC38F-24C5-8315-AE9C-004BF6ACD2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315AEE-88A0-82B4-BD39-706349005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39231-6C84-ADD5-596E-4177AC69D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0BCC50-8524-4074-1670-E5D786AC8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89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A53D37-90B1-202F-3AD0-EBF1FC150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C32392-EE47-CDB6-83C1-6EB353F07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AF5D4-05BE-EB2F-88FB-0FC2D0D00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57E5BA-3D18-0FA9-1D42-E18D44D1B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42FFC-BDCA-A95D-396F-973FFC2E4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141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C095C6-C9E8-FB82-9F11-C00313CF24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48B12E-21BC-FAA0-E2FB-FDFFBBA218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6A70C8-2450-17AD-7D85-69DA391B5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93BB6C-57AD-2242-4E89-9637448DE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4175AC-51E4-B389-4030-530FEF41D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16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0F2E4F-08A9-40DB-3033-3B933BD9BC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738503-7176-9B3B-5C8D-BCA3161551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A82559-F95B-8E96-9FA8-96FF16D0B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197C59-0B75-7C23-79DD-0651CA5FC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AA89E1-22BD-EE41-6B6B-064E253ED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991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BA1FA-13EE-BFEA-2D5D-D3A5863F0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05D58D-9E36-5196-8542-64E420E115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FEDDE-633C-14B1-84F7-47AE4499C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950238-96DF-C152-8597-E1A3F7A30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13872-ADD8-9273-ED31-D07A9FA90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473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313ACA-BFDD-4DC5-14D8-B00BD80BC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743C8B-8D18-AFEC-6601-F56BACA863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B7A862-B9AD-B3F3-C004-7CE15131A0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80B1FD-7EE6-DB56-BF44-5FFB38AFE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FC0F65-D0A9-4714-C0DB-C900EDB03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ED7C3B-66E1-676F-5B0A-763CA0F0B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38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6F3FBB-B422-D3C4-78AC-027B5FBB1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DBAC01-BDA2-AF70-7622-57445AE2A8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3C5968-2946-EE7E-75CF-301589BAAA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11118F-32CE-3B4B-61C0-7B1AF2F02A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CAC9EA-F78D-96D3-3EFF-469A639622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982B47-A01F-F042-A795-17A637401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15150B-C4AC-24FF-EE09-379F195D8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A325F5-EF6F-AE79-C68B-4E955433F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825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8E5B0-E7D0-EBC9-3997-6222682FEE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D89746-15C0-887D-3019-30032D5F8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37F342-78D1-50FB-5D8E-89B32F190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3D4E2E-2BDF-4146-8D17-FA8F0FAAC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262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A45E4F-6DA3-EBFE-37CE-AF6E8B39F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CB475F-A69A-6341-785E-CCA247CF1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5A66F2-B04E-A2ED-1529-70BA49328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105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905382-F992-FAF1-13C5-56DC907FB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68F99-BEFF-4A7F-3B3C-9BA927C359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7AEB03-1BD7-BBCE-06D9-BAA1938073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37AD2C-088F-F033-E0C3-A73CA4DD3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0B22E0-5A13-FA3D-7014-81D14E3EB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238615-07BA-8828-E1BE-A49E5536A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10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C7173-3DA8-BCBF-E042-0C59EE228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6D45F1-CBC1-80F3-6C55-D601BE19BD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874A42-260A-50C4-BB41-29C5863E6D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9D15D-E4E0-68BC-D044-D68991A4F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AAF316-23C9-EC40-1922-D459DE58B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A9525D-2036-A412-3CFD-EBA10F090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09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21340F-E212-7A2D-B7A3-0BAF7D6D95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5467FB-A828-6472-9431-28965C9901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26315D-2932-5DE4-C911-1910E5E057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D94A147-1434-824B-8A66-94B2F6F812A8}" type="datetimeFigureOut">
              <a:rPr lang="en-US" smtClean="0"/>
              <a:t>6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782174-57CD-652D-9C31-049E67B0CE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25F4CE-8F51-DDC1-85D3-45092E28A4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F6B6F3-72B5-914D-A196-346FD14D5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3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90B5E804-A781-9754-CA13-5FB8F9B5C3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7CC45326-E7DD-C1E5-F080-EA0157DEEA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0578" y="457200"/>
            <a:ext cx="10152011" cy="45825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BD28D2B-80D7-72CE-5216-4DFF02BB835C}"/>
              </a:ext>
            </a:extLst>
          </p:cNvPr>
          <p:cNvSpPr txBox="1"/>
          <p:nvPr/>
        </p:nvSpPr>
        <p:spPr>
          <a:xfrm>
            <a:off x="740578" y="5477470"/>
            <a:ext cx="107419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1: GLIMPSE imputation performed comparatively poorly on the Bos indicus samples, in particular for rarer variants.</a:t>
            </a:r>
            <a:endParaRPr kumimoji="0" lang="en-US" altLang="en-US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89505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7D1E5B-2383-2CDE-48E2-3E4E7F9A43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585143" y="-1937276"/>
            <a:ext cx="9332654" cy="1073255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985122F-A62A-9F19-292D-78AF4844DB67}"/>
              </a:ext>
            </a:extLst>
          </p:cNvPr>
          <p:cNvSpPr txBox="1"/>
          <p:nvPr/>
        </p:nvSpPr>
        <p:spPr>
          <a:xfrm>
            <a:off x="1149927" y="6377612"/>
            <a:ext cx="9892146" cy="480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10: Transcripts with significant TWAS associations summarised for each of the traits analysed (BH corrected p-value &lt;0.05). Overlaps in tissue-specificity, chromosomal location and start position are shown for each transcript.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FA49E6-2966-B0BF-7E3C-FBAA088AD525}"/>
              </a:ext>
            </a:extLst>
          </p:cNvPr>
          <p:cNvSpPr txBox="1"/>
          <p:nvPr/>
        </p:nvSpPr>
        <p:spPr>
          <a:xfrm>
            <a:off x="5926485" y="128336"/>
            <a:ext cx="8386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ranscrip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723083B-3A6C-4B84-441A-CD836E72C0FF}"/>
              </a:ext>
            </a:extLst>
          </p:cNvPr>
          <p:cNvSpPr txBox="1"/>
          <p:nvPr/>
        </p:nvSpPr>
        <p:spPr>
          <a:xfrm rot="16200000">
            <a:off x="134516" y="2975323"/>
            <a:ext cx="12397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Trait</a:t>
            </a:r>
          </a:p>
        </p:txBody>
      </p:sp>
    </p:spTree>
    <p:extLst>
      <p:ext uri="{BB962C8B-B14F-4D97-AF65-F5344CB8AC3E}">
        <p14:creationId xmlns:p14="http://schemas.microsoft.com/office/powerpoint/2010/main" val="2945059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1E5ED20-41D7-CA04-9695-177737A90F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2">
            <a:extLst>
              <a:ext uri="{FF2B5EF4-FFF2-40B4-BE49-F238E27FC236}">
                <a16:creationId xmlns:a16="http://schemas.microsoft.com/office/drawing/2014/main" id="{E44AE657-C129-F974-B016-79BB1F664D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3113" y="457200"/>
            <a:ext cx="7429500" cy="52714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158FC25A-90C1-F06A-9D89-15528A1AA3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063" y="5639453"/>
            <a:ext cx="10329862" cy="815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Yu Gothic Light" panose="020B0300000000000000" pitchFamily="34" charset="-128"/>
              </a:rPr>
              <a:t> 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2: ETH Gene 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&lt;0.05 and rho avg.&gt;0.1).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38970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43E38F5-14A5-47F9-CA2A-E2EFB6564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3073" name="Picture 4">
            <a:extLst>
              <a:ext uri="{FF2B5EF4-FFF2-40B4-BE49-F238E27FC236}">
                <a16:creationId xmlns:a16="http://schemas.microsoft.com/office/drawing/2014/main" id="{39DADA1B-37B3-EEDB-67DA-D041AA66DE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2675" y="457200"/>
            <a:ext cx="7486650" cy="5283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CAECAA19-805E-0B4B-6337-696B48C8C9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0075" y="5716110"/>
            <a:ext cx="1077277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3: ETH transcript 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&lt;0.05 and rho avg.&gt;0.1)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72060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0C8A44B-6C42-9592-2621-078DC7ADB5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4097" name="Picture 914341003">
            <a:extLst>
              <a:ext uri="{FF2B5EF4-FFF2-40B4-BE49-F238E27FC236}">
                <a16:creationId xmlns:a16="http://schemas.microsoft.com/office/drawing/2014/main" id="{865A7CE6-753A-B794-FAAC-31489895D6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7399" y="434149"/>
            <a:ext cx="7700963" cy="54470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AB38AF5E-7D34-79D8-997E-771E2E798C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206" y="5881172"/>
            <a:ext cx="1152048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4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 INRAE Gene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&lt;0.05 and rho avg.&gt;0.1)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0660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B9F4C706-C233-7BF7-E182-0F9D25AC7D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5121" name="Picture 63468916">
            <a:extLst>
              <a:ext uri="{FF2B5EF4-FFF2-40B4-BE49-F238E27FC236}">
                <a16:creationId xmlns:a16="http://schemas.microsoft.com/office/drawing/2014/main" id="{10BDC881-7271-A891-679F-33D525A942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6930" y="344359"/>
            <a:ext cx="7958138" cy="56289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B8696485-FEDA-0D9F-1483-C0032BD618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587" y="5973286"/>
            <a:ext cx="1117282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5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 INRAE transcript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&lt;0.05 and rho avg.&gt;0.1)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2224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0630864A-6D17-3951-AFCA-41D60C5410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6145" name="Picture 9284271">
            <a:extLst>
              <a:ext uri="{FF2B5EF4-FFF2-40B4-BE49-F238E27FC236}">
                <a16:creationId xmlns:a16="http://schemas.microsoft.com/office/drawing/2014/main" id="{709BB8E2-F451-741A-DB2D-617AB52F43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6" y="339338"/>
            <a:ext cx="7643813" cy="54065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393E715C-07FD-D397-CE76-5F9DB4D02E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459" y="5872331"/>
            <a:ext cx="1182708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6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 FBN</a:t>
            </a:r>
            <a:r>
              <a:rPr kumimoji="0" lang="en-US" altLang="en-US" b="0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gen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&lt;0.05 and rho avg.&gt;0.1)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5185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E6A307B6-A52E-A451-C8D9-28C4E2C213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7169" name="Picture 1986876043">
            <a:extLst>
              <a:ext uri="{FF2B5EF4-FFF2-40B4-BE49-F238E27FC236}">
                <a16:creationId xmlns:a16="http://schemas.microsoft.com/office/drawing/2014/main" id="{30682D29-8EF4-7FCC-7DD6-82E14A04EE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0188" y="198083"/>
            <a:ext cx="8034711" cy="5683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A9622237-5B85-D6FC-22E3-539BBE4842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806" y="5881171"/>
            <a:ext cx="11234388" cy="6625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7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 FBN transcript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odel counts shared across tissues for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ctDB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rained models (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zscore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val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&lt;0.05 and rho avg.&gt;0.1)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49412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omputer&#10;&#10;AI-generated content may be incorrect.">
            <a:extLst>
              <a:ext uri="{FF2B5EF4-FFF2-40B4-BE49-F238E27FC236}">
                <a16:creationId xmlns:a16="http://schemas.microsoft.com/office/drawing/2014/main" id="{A78408E9-E0A1-4870-76B4-2D786ADFA6E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9064"/>
            <a:ext cx="12046979" cy="54121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709C2FC-A580-AAC6-CEF6-2C3CB851EA22}"/>
              </a:ext>
            </a:extLst>
          </p:cNvPr>
          <p:cNvSpPr txBox="1"/>
          <p:nvPr/>
        </p:nvSpPr>
        <p:spPr>
          <a:xfrm>
            <a:off x="472232" y="6047778"/>
            <a:ext cx="11237626" cy="810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1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8: Visualisation of genes with significant TWAS associations across each of the </a:t>
            </a:r>
            <a:r>
              <a:rPr lang="en-GB" sz="1100" kern="100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ve </a:t>
            </a:r>
            <a:r>
              <a:rPr lang="en-GB" sz="11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issues types for all of the traits analysed (p-value &lt;0.05, Bonferroni corrected). Integration of the SNP genotyping, gene expression, and GWAS summary data using 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-</a:t>
            </a:r>
            <a:r>
              <a:rPr lang="en-GB" sz="11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Xcan</a:t>
            </a:r>
            <a:r>
              <a:rPr lang="en-GB" sz="11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White areas indicate no valid model was trained for the gene indicated on the X axis in the given tissue (labelled to the right). Grey areas mean a valid model was trained but the gene’s expression was not significantly associated with the trait indicated on the left Y axis. Coloured boxes indicate the gene’s expression was significantly associated with the given trait in the specified tissue.</a:t>
            </a:r>
            <a:endParaRPr lang="en-GB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3FBFED-7AE1-CA61-E62D-807F98EA2133}"/>
              </a:ext>
            </a:extLst>
          </p:cNvPr>
          <p:cNvSpPr txBox="1"/>
          <p:nvPr/>
        </p:nvSpPr>
        <p:spPr>
          <a:xfrm>
            <a:off x="6539856" y="5711252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rai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1C4B2E-2DE7-7EEF-CA05-88039BC99DEB}"/>
              </a:ext>
            </a:extLst>
          </p:cNvPr>
          <p:cNvSpPr txBox="1"/>
          <p:nvPr/>
        </p:nvSpPr>
        <p:spPr>
          <a:xfrm rot="16200000">
            <a:off x="108954" y="2743548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ene</a:t>
            </a:r>
          </a:p>
        </p:txBody>
      </p:sp>
    </p:spTree>
    <p:extLst>
      <p:ext uri="{BB962C8B-B14F-4D97-AF65-F5344CB8AC3E}">
        <p14:creationId xmlns:p14="http://schemas.microsoft.com/office/powerpoint/2010/main" val="36060722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CFE0A6C-D3BF-B06B-BA30-66039312F6FA}"/>
              </a:ext>
            </a:extLst>
          </p:cNvPr>
          <p:cNvSpPr txBox="1"/>
          <p:nvPr/>
        </p:nvSpPr>
        <p:spPr>
          <a:xfrm>
            <a:off x="7064679" y="5799551"/>
            <a:ext cx="4794812" cy="8859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9: Visualisation of transcripts with significant TWAS associations across each of the five tissues analysed for the traits analysed (BH corrected p-value &lt;0.05). Integration the SNP genotyping, transcript expression, and GWAS summary data using </a:t>
            </a:r>
            <a:r>
              <a:rPr lang="en-GB" sz="1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-</a:t>
            </a:r>
            <a:r>
              <a:rPr lang="en-GB" sz="12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ediXcan</a:t>
            </a:r>
            <a:r>
              <a:rPr lang="en-GB" sz="1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3204B1-C08C-9F50-B4F7-E84C13EC96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509" y="13784"/>
            <a:ext cx="5951492" cy="684421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C58B59-B5D9-A72C-8D0D-64572119A30F}"/>
              </a:ext>
            </a:extLst>
          </p:cNvPr>
          <p:cNvSpPr txBox="1"/>
          <p:nvPr/>
        </p:nvSpPr>
        <p:spPr>
          <a:xfrm rot="16200000">
            <a:off x="-217641" y="2756074"/>
            <a:ext cx="8386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ranscrip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70BAAC-F302-5860-198F-538BDF52F5A1}"/>
              </a:ext>
            </a:extLst>
          </p:cNvPr>
          <p:cNvSpPr txBox="1"/>
          <p:nvPr/>
        </p:nvSpPr>
        <p:spPr>
          <a:xfrm>
            <a:off x="6284001" y="6610861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rait</a:t>
            </a:r>
          </a:p>
        </p:txBody>
      </p:sp>
    </p:spTree>
    <p:extLst>
      <p:ext uri="{BB962C8B-B14F-4D97-AF65-F5344CB8AC3E}">
        <p14:creationId xmlns:p14="http://schemas.microsoft.com/office/powerpoint/2010/main" val="1216751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84</Words>
  <Application>Microsoft Macintosh PowerPoint</Application>
  <PresentationFormat>Widescreen</PresentationFormat>
  <Paragraphs>1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mily Clark</dc:creator>
  <cp:lastModifiedBy>Emily Clark</cp:lastModifiedBy>
  <cp:revision>4</cp:revision>
  <dcterms:created xsi:type="dcterms:W3CDTF">2025-05-04T10:52:06Z</dcterms:created>
  <dcterms:modified xsi:type="dcterms:W3CDTF">2025-06-08T15:36:31Z</dcterms:modified>
</cp:coreProperties>
</file>